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60" r:id="rId4"/>
    <p:sldId id="257" r:id="rId5"/>
    <p:sldId id="261" r:id="rId6"/>
    <p:sldId id="258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3" autoAdjust="0"/>
    <p:restoredTop sz="95970"/>
  </p:normalViewPr>
  <p:slideViewPr>
    <p:cSldViewPr snapToGrid="0" showGuides="1">
      <p:cViewPr varScale="1">
        <p:scale>
          <a:sx n="112" d="100"/>
          <a:sy n="112" d="100"/>
        </p:scale>
        <p:origin x="400" y="184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ovanni Mannino" userId="36b7467c-a84b-40f1-b124-73228c8ffa41" providerId="ADAL" clId="{A2A0612D-91C3-564F-9A73-EEB9C276ABB2}"/>
    <pc:docChg chg="undo redo custSel modSld">
      <pc:chgData name="Giovanni Mannino" userId="36b7467c-a84b-40f1-b124-73228c8ffa41" providerId="ADAL" clId="{A2A0612D-91C3-564F-9A73-EEB9C276ABB2}" dt="2022-12-20T08:12:32.168" v="263" actId="164"/>
      <pc:docMkLst>
        <pc:docMk/>
      </pc:docMkLst>
      <pc:sldChg chg="modSp mod">
        <pc:chgData name="Giovanni Mannino" userId="36b7467c-a84b-40f1-b124-73228c8ffa41" providerId="ADAL" clId="{A2A0612D-91C3-564F-9A73-EEB9C276ABB2}" dt="2022-12-20T08:09:54.361" v="156" actId="20577"/>
        <pc:sldMkLst>
          <pc:docMk/>
          <pc:sldMk cId="2012535592" sldId="256"/>
        </pc:sldMkLst>
        <pc:spChg chg="mod">
          <ac:chgData name="Giovanni Mannino" userId="36b7467c-a84b-40f1-b124-73228c8ffa41" providerId="ADAL" clId="{A2A0612D-91C3-564F-9A73-EEB9C276ABB2}" dt="2022-12-20T08:09:54.361" v="156" actId="20577"/>
          <ac:spMkLst>
            <pc:docMk/>
            <pc:sldMk cId="2012535592" sldId="256"/>
            <ac:spMk id="2" creationId="{751728C5-FDF0-AF18-4902-7BE96E915313}"/>
          </ac:spMkLst>
        </pc:spChg>
        <pc:spChg chg="mod">
          <ac:chgData name="Giovanni Mannino" userId="36b7467c-a84b-40f1-b124-73228c8ffa41" providerId="ADAL" clId="{A2A0612D-91C3-564F-9A73-EEB9C276ABB2}" dt="2022-12-20T08:08:04.775" v="149" actId="1076"/>
          <ac:spMkLst>
            <pc:docMk/>
            <pc:sldMk cId="2012535592" sldId="256"/>
            <ac:spMk id="6" creationId="{63D0AEA8-3728-4E2F-8B68-DB2F3AE07AE9}"/>
          </ac:spMkLst>
        </pc:spChg>
        <pc:picChg chg="mod">
          <ac:chgData name="Giovanni Mannino" userId="36b7467c-a84b-40f1-b124-73228c8ffa41" providerId="ADAL" clId="{A2A0612D-91C3-564F-9A73-EEB9C276ABB2}" dt="2022-12-20T08:08:04.775" v="149" actId="1076"/>
          <ac:picMkLst>
            <pc:docMk/>
            <pc:sldMk cId="2012535592" sldId="256"/>
            <ac:picMk id="5" creationId="{BF7E6209-0F7A-4783-8326-6CC2D5E7243D}"/>
          </ac:picMkLst>
        </pc:picChg>
      </pc:sldChg>
      <pc:sldChg chg="modSp mod">
        <pc:chgData name="Giovanni Mannino" userId="36b7467c-a84b-40f1-b124-73228c8ffa41" providerId="ADAL" clId="{A2A0612D-91C3-564F-9A73-EEB9C276ABB2}" dt="2022-12-20T08:09:51.418" v="155" actId="20577"/>
        <pc:sldMkLst>
          <pc:docMk/>
          <pc:sldMk cId="1326919899" sldId="257"/>
        </pc:sldMkLst>
        <pc:spChg chg="mod">
          <ac:chgData name="Giovanni Mannino" userId="36b7467c-a84b-40f1-b124-73228c8ffa41" providerId="ADAL" clId="{A2A0612D-91C3-564F-9A73-EEB9C276ABB2}" dt="2022-12-20T08:09:51.418" v="155" actId="20577"/>
          <ac:spMkLst>
            <pc:docMk/>
            <pc:sldMk cId="1326919899" sldId="257"/>
            <ac:spMk id="6" creationId="{9594EC69-CD55-D454-3EEC-D146C5D4DE1C}"/>
          </ac:spMkLst>
        </pc:spChg>
      </pc:sldChg>
      <pc:sldChg chg="modSp mod">
        <pc:chgData name="Giovanni Mannino" userId="36b7467c-a84b-40f1-b124-73228c8ffa41" providerId="ADAL" clId="{A2A0612D-91C3-564F-9A73-EEB9C276ABB2}" dt="2022-12-20T08:09:57.676" v="157" actId="20577"/>
        <pc:sldMkLst>
          <pc:docMk/>
          <pc:sldMk cId="3866587081" sldId="258"/>
        </pc:sldMkLst>
        <pc:spChg chg="mod">
          <ac:chgData name="Giovanni Mannino" userId="36b7467c-a84b-40f1-b124-73228c8ffa41" providerId="ADAL" clId="{A2A0612D-91C3-564F-9A73-EEB9C276ABB2}" dt="2022-12-20T08:08:16.901" v="150" actId="1076"/>
          <ac:spMkLst>
            <pc:docMk/>
            <pc:sldMk cId="3866587081" sldId="258"/>
            <ac:spMk id="5" creationId="{45EA6A2F-93D7-7C7C-7A1A-4DB1D543B456}"/>
          </ac:spMkLst>
        </pc:spChg>
        <pc:spChg chg="mod">
          <ac:chgData name="Giovanni Mannino" userId="36b7467c-a84b-40f1-b124-73228c8ffa41" providerId="ADAL" clId="{A2A0612D-91C3-564F-9A73-EEB9C276ABB2}" dt="2022-12-20T08:09:57.676" v="157" actId="20577"/>
          <ac:spMkLst>
            <pc:docMk/>
            <pc:sldMk cId="3866587081" sldId="258"/>
            <ac:spMk id="6" creationId="{C0D0554D-17C7-7A1D-5ABE-A732A4D4FFA7}"/>
          </ac:spMkLst>
        </pc:spChg>
        <pc:picChg chg="mod">
          <ac:chgData name="Giovanni Mannino" userId="36b7467c-a84b-40f1-b124-73228c8ffa41" providerId="ADAL" clId="{A2A0612D-91C3-564F-9A73-EEB9C276ABB2}" dt="2022-12-20T08:08:16.901" v="150" actId="1076"/>
          <ac:picMkLst>
            <pc:docMk/>
            <pc:sldMk cId="3866587081" sldId="258"/>
            <ac:picMk id="4" creationId="{6A15F80E-B325-DD28-D67C-CE208DF5F117}"/>
          </ac:picMkLst>
        </pc:picChg>
      </pc:sldChg>
      <pc:sldChg chg="modSp mod">
        <pc:chgData name="Giovanni Mannino" userId="36b7467c-a84b-40f1-b124-73228c8ffa41" providerId="ADAL" clId="{A2A0612D-91C3-564F-9A73-EEB9C276ABB2}" dt="2022-12-20T08:08:25.209" v="154" actId="20577"/>
        <pc:sldMkLst>
          <pc:docMk/>
          <pc:sldMk cId="2013389381" sldId="259"/>
        </pc:sldMkLst>
        <pc:spChg chg="mod">
          <ac:chgData name="Giovanni Mannino" userId="36b7467c-a84b-40f1-b124-73228c8ffa41" providerId="ADAL" clId="{A2A0612D-91C3-564F-9A73-EEB9C276ABB2}" dt="2022-12-20T08:08:25.209" v="154" actId="20577"/>
          <ac:spMkLst>
            <pc:docMk/>
            <pc:sldMk cId="2013389381" sldId="259"/>
            <ac:spMk id="5" creationId="{7FA4DD87-415E-15CB-5A10-B6AFCD20F3DA}"/>
          </ac:spMkLst>
        </pc:spChg>
      </pc:sldChg>
      <pc:sldChg chg="modSp mod">
        <pc:chgData name="Giovanni Mannino" userId="36b7467c-a84b-40f1-b124-73228c8ffa41" providerId="ADAL" clId="{A2A0612D-91C3-564F-9A73-EEB9C276ABB2}" dt="2022-12-20T08:12:17.892" v="262" actId="1076"/>
        <pc:sldMkLst>
          <pc:docMk/>
          <pc:sldMk cId="3061078961" sldId="260"/>
        </pc:sldMkLst>
        <pc:spChg chg="mod">
          <ac:chgData name="Giovanni Mannino" userId="36b7467c-a84b-40f1-b124-73228c8ffa41" providerId="ADAL" clId="{A2A0612D-91C3-564F-9A73-EEB9C276ABB2}" dt="2022-12-20T08:10:53.592" v="217" actId="20577"/>
          <ac:spMkLst>
            <pc:docMk/>
            <pc:sldMk cId="3061078961" sldId="260"/>
            <ac:spMk id="8" creationId="{4BE83654-FF1E-45A8-9334-2FD37A1D4663}"/>
          </ac:spMkLst>
        </pc:spChg>
        <pc:spChg chg="mod">
          <ac:chgData name="Giovanni Mannino" userId="36b7467c-a84b-40f1-b124-73228c8ffa41" providerId="ADAL" clId="{A2A0612D-91C3-564F-9A73-EEB9C276ABB2}" dt="2022-12-20T08:12:17.892" v="262" actId="1076"/>
          <ac:spMkLst>
            <pc:docMk/>
            <pc:sldMk cId="3061078961" sldId="260"/>
            <ac:spMk id="11" creationId="{8A057899-9D4D-426D-9081-9409D280B643}"/>
          </ac:spMkLst>
        </pc:spChg>
        <pc:spChg chg="mod">
          <ac:chgData name="Giovanni Mannino" userId="36b7467c-a84b-40f1-b124-73228c8ffa41" providerId="ADAL" clId="{A2A0612D-91C3-564F-9A73-EEB9C276ABB2}" dt="2022-12-20T08:12:17.892" v="262" actId="1076"/>
          <ac:spMkLst>
            <pc:docMk/>
            <pc:sldMk cId="3061078961" sldId="260"/>
            <ac:spMk id="12" creationId="{FA4BC141-D1E3-4D27-AF28-1AF7B6409562}"/>
          </ac:spMkLst>
        </pc:spChg>
      </pc:sldChg>
      <pc:sldChg chg="modSp mod">
        <pc:chgData name="Giovanni Mannino" userId="36b7467c-a84b-40f1-b124-73228c8ffa41" providerId="ADAL" clId="{A2A0612D-91C3-564F-9A73-EEB9C276ABB2}" dt="2022-12-20T08:11:14.655" v="221" actId="20577"/>
        <pc:sldMkLst>
          <pc:docMk/>
          <pc:sldMk cId="1301950954" sldId="261"/>
        </pc:sldMkLst>
        <pc:spChg chg="mod">
          <ac:chgData name="Giovanni Mannino" userId="36b7467c-a84b-40f1-b124-73228c8ffa41" providerId="ADAL" clId="{A2A0612D-91C3-564F-9A73-EEB9C276ABB2}" dt="2022-12-20T08:11:14.655" v="221" actId="20577"/>
          <ac:spMkLst>
            <pc:docMk/>
            <pc:sldMk cId="1301950954" sldId="261"/>
            <ac:spMk id="8" creationId="{2E829B94-CF78-449B-894D-2CEA6402EF09}"/>
          </ac:spMkLst>
        </pc:spChg>
      </pc:sldChg>
      <pc:sldChg chg="addSp modSp mod">
        <pc:chgData name="Giovanni Mannino" userId="36b7467c-a84b-40f1-b124-73228c8ffa41" providerId="ADAL" clId="{A2A0612D-91C3-564F-9A73-EEB9C276ABB2}" dt="2022-12-20T08:12:32.168" v="263" actId="164"/>
        <pc:sldMkLst>
          <pc:docMk/>
          <pc:sldMk cId="2894214736" sldId="262"/>
        </pc:sldMkLst>
        <pc:spChg chg="mod">
          <ac:chgData name="Giovanni Mannino" userId="36b7467c-a84b-40f1-b124-73228c8ffa41" providerId="ADAL" clId="{A2A0612D-91C3-564F-9A73-EEB9C276ABB2}" dt="2022-12-20T08:11:42.807" v="244" actId="20577"/>
          <ac:spMkLst>
            <pc:docMk/>
            <pc:sldMk cId="2894214736" sldId="262"/>
            <ac:spMk id="9" creationId="{4289AA0C-026C-44A6-94D0-B8DB734F481C}"/>
          </ac:spMkLst>
        </pc:spChg>
        <pc:spChg chg="mod">
          <ac:chgData name="Giovanni Mannino" userId="36b7467c-a84b-40f1-b124-73228c8ffa41" providerId="ADAL" clId="{A2A0612D-91C3-564F-9A73-EEB9C276ABB2}" dt="2022-12-20T08:12:32.168" v="263" actId="164"/>
          <ac:spMkLst>
            <pc:docMk/>
            <pc:sldMk cId="2894214736" sldId="262"/>
            <ac:spMk id="10" creationId="{A3B6233C-7C2A-40AC-B8B2-2378BB6B5030}"/>
          </ac:spMkLst>
        </pc:spChg>
        <pc:spChg chg="mod">
          <ac:chgData name="Giovanni Mannino" userId="36b7467c-a84b-40f1-b124-73228c8ffa41" providerId="ADAL" clId="{A2A0612D-91C3-564F-9A73-EEB9C276ABB2}" dt="2022-12-20T08:12:32.168" v="263" actId="164"/>
          <ac:spMkLst>
            <pc:docMk/>
            <pc:sldMk cId="2894214736" sldId="262"/>
            <ac:spMk id="11" creationId="{410C2C58-481A-4510-8767-FFEA71A66DF0}"/>
          </ac:spMkLst>
        </pc:spChg>
        <pc:grpChg chg="add mod">
          <ac:chgData name="Giovanni Mannino" userId="36b7467c-a84b-40f1-b124-73228c8ffa41" providerId="ADAL" clId="{A2A0612D-91C3-564F-9A73-EEB9C276ABB2}" dt="2022-12-20T08:12:32.168" v="263" actId="164"/>
          <ac:grpSpMkLst>
            <pc:docMk/>
            <pc:sldMk cId="2894214736" sldId="262"/>
            <ac:grpSpMk id="2" creationId="{654B8D4B-02D9-E2F5-14CA-577DF0DC8B62}"/>
          </ac:grpSpMkLst>
        </pc:grpChg>
        <pc:picChg chg="mod">
          <ac:chgData name="Giovanni Mannino" userId="36b7467c-a84b-40f1-b124-73228c8ffa41" providerId="ADAL" clId="{A2A0612D-91C3-564F-9A73-EEB9C276ABB2}" dt="2022-12-20T08:12:32.168" v="263" actId="164"/>
          <ac:picMkLst>
            <pc:docMk/>
            <pc:sldMk cId="2894214736" sldId="262"/>
            <ac:picMk id="5" creationId="{F37A5164-F078-4AAC-936F-D5A2D509CADC}"/>
          </ac:picMkLst>
        </pc:picChg>
        <pc:picChg chg="mod">
          <ac:chgData name="Giovanni Mannino" userId="36b7467c-a84b-40f1-b124-73228c8ffa41" providerId="ADAL" clId="{A2A0612D-91C3-564F-9A73-EEB9C276ABB2}" dt="2022-12-20T08:12:32.168" v="263" actId="164"/>
          <ac:picMkLst>
            <pc:docMk/>
            <pc:sldMk cId="2894214736" sldId="262"/>
            <ac:picMk id="7" creationId="{D55CD15E-BAAD-4746-A3FA-3F755D91101C}"/>
          </ac:picMkLst>
        </pc:picChg>
        <pc:picChg chg="mod">
          <ac:chgData name="Giovanni Mannino" userId="36b7467c-a84b-40f1-b124-73228c8ffa41" providerId="ADAL" clId="{A2A0612D-91C3-564F-9A73-EEB9C276ABB2}" dt="2022-12-20T08:12:32.168" v="263" actId="164"/>
          <ac:picMkLst>
            <pc:docMk/>
            <pc:sldMk cId="2894214736" sldId="262"/>
            <ac:picMk id="8" creationId="{0E2198AB-BCFD-4ED8-BF4C-5BC4B9A9972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584D44E-B307-4DA2-8B5E-3C1390D036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0510E92-871B-40A0-B37A-100431E1DC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BB81775-28CB-4D9A-BAE4-929E3AC37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680C9D9-2F26-4F18-80AD-A85225F20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FCE093-9393-4D70-8613-02CC6E3AF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498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5D680AD-0313-40E6-9681-44497072D8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5CE2B06-5B38-4076-84B1-9B4A711ECA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1B678C1-D888-4785-9EEF-6EAFD40B9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55BA03C-F7F9-4BCE-B5BE-86DA20176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DDE57E5-89B5-4475-84CA-69C12B260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455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4A9EBB4-37C1-494B-B168-4AA45C4065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B1CA236-FDAF-4417-9575-45EF246C99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265039D-6131-4A4F-A2A6-621862A2F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778916-D15A-41A2-BE3F-0B3E37FE0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C3C3341-9B47-47BC-B7B1-A5D8BCC1D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27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90AC60-1381-4372-BE20-60ABA461EA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85C4528-BA37-437E-AB81-041BB170C1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80A5345-44BF-4A16-B16B-9AD83B5E4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087FD90-EE41-414A-B584-2C412B0B0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0BAE2EF-C214-4E77-A22E-5DFEE93F3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22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B53B12-5ADA-4C6F-B54E-94BA2CA49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34EBEA-A98E-44E0-8DBB-7849A64577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4CD9ACA-4F41-402C-9AEF-B87870FCC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9831F59-6652-4127-B031-EE7B448E2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77906E4-F4FA-40EE-A5F6-290CEB16A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094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F5FCBD-091C-4912-9527-BD7C46F230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6FC0691-0D9F-4F95-A14C-82B9780FB8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0EFAEF4-A347-4447-BAC9-96496846D6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ECFCFF-8317-4E66-BD4F-820262492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39942CF-7F4E-428F-9D78-F8467D307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C33F258-4C5E-4C06-BCA3-CB62FA876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042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58D78F-1C82-432B-846C-EFFD57CB6C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9DE10FE-5385-46A3-8862-CB55A77708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19ED7ED-6ADC-410F-81E5-892D2A70DA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F3CD96D-F7D6-46EE-9C4D-76B6F79ED8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5F9F277-BDC8-4F4D-802A-2303871196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A76198FA-5173-4F41-A690-098FC3117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3E3AF50-BFC9-43FE-A0FB-6FD2400E1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0167AB4-9DCE-4C96-A4CB-59382F814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268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7AEE6F-DEF6-40CE-A513-CAD909B9B9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747B182-492F-4463-8990-7F8764CCDE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D1E06A4-4957-4944-A6BD-E83BFF4A1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E6092F6-4AB7-420B-B927-824B6308D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759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68DB174-14EF-4C05-B97E-5A08780DF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5935DCD-3FEE-456E-93CF-5B57B473F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B01E6A1-8476-4908-93FA-ADFAACC5C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862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89D1F21-8672-4EA3-8072-BC3365636E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B8AD81D-D36D-45BC-BA57-7DD098EA43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BD43678-2169-4711-8853-7D5C8A010F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6CF5085-3680-4BAC-AC38-7CA27F753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2F0FDDE-0677-4CF6-973F-6B4326E78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E68A553-9876-4E2A-A826-CCD31F691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777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9EC8CC6-A49E-4998-8D40-CF9AF794F0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68E86E0-02DB-4586-9F46-3579EC9D0A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1C5B2BC-2180-4279-AE0F-A28EB5447E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21615E-C37B-4E88-998C-995B2D44E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F352227-D57D-4052-9C5E-B268C34F7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88532C6-11E1-4A0E-B542-34B152D83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029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16E4646-6EAD-4A55-8B18-2E4F677C8A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3FB1A93-716F-4F58-B279-012021D754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0617B1E-B31B-44DD-B7F8-B10F66F8D5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DC9A88-05DE-44FC-B1C4-8F5D79DED139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27AD597-12DB-475A-BC6F-923475F2E4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1EA2BF3-6CB1-499E-999B-F253C8794B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D9005-5F6E-4F5E-B9C3-BFBC09AA15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636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FA4DD87-415E-15CB-5A10-B6AFCD20F3DA}"/>
              </a:ext>
            </a:extLst>
          </p:cNvPr>
          <p:cNvSpPr txBox="1"/>
          <p:nvPr/>
        </p:nvSpPr>
        <p:spPr>
          <a:xfrm>
            <a:off x="1556181" y="1307600"/>
            <a:ext cx="9079637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3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man amplification for trapped radiation in </a:t>
            </a:r>
            <a:r>
              <a:rPr lang="it-IT" sz="3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ystalline</a:t>
            </a:r>
            <a:r>
              <a:rPr lang="it-IT" sz="3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ingle Si </a:t>
            </a:r>
            <a:r>
              <a:rPr lang="it-IT" sz="3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anoparticle</a:t>
            </a:r>
            <a:endParaRPr lang="it-IT" sz="3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it-IT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. Mannino</a:t>
            </a:r>
            <a:r>
              <a:rPr lang="it-IT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</a:t>
            </a:r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M. Condorelli</a:t>
            </a:r>
            <a:r>
              <a:rPr lang="it-IT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*, G. Compagnini</a:t>
            </a:r>
            <a:r>
              <a:rPr lang="it-IT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G. Faraci</a:t>
            </a:r>
            <a:r>
              <a:rPr lang="it-IT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3</a:t>
            </a:r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it-IT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</a:t>
            </a:r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NR-IMM, Zona Industriale Strada VIII n°5, 95121 Catania (Italy)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it-IT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ipartimento di Scienze Chimiche, Università di Catania, Via Santa Sofia 64, 95123 Catania, (Italy)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it-IT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3</a:t>
            </a:r>
            <a:r>
              <a:rPr lang="it-IT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ipartimento di Fisica e Astronomia, Università di Catania, Via Santa Sofia 64, 95123 Catania, (Italy)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3389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532 nm">
            <a:hlinkClick r:id="" action="ppaction://media"/>
            <a:extLst>
              <a:ext uri="{FF2B5EF4-FFF2-40B4-BE49-F238E27FC236}">
                <a16:creationId xmlns:a16="http://schemas.microsoft.com/office/drawing/2014/main" id="{BF7E6209-0F7A-4783-8326-6CC2D5E7243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715256" y="474424"/>
            <a:ext cx="8761488" cy="4380744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63D0AEA8-3728-4E2F-8B68-DB2F3AE07AE9}"/>
              </a:ext>
            </a:extLst>
          </p:cNvPr>
          <p:cNvSpPr txBox="1"/>
          <p:nvPr/>
        </p:nvSpPr>
        <p:spPr>
          <a:xfrm>
            <a:off x="5624946" y="4108513"/>
            <a:ext cx="942109" cy="3786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532 nm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1728C5-FDF0-AF18-4902-7BE96E915313}"/>
              </a:ext>
            </a:extLst>
          </p:cNvPr>
          <p:cNvSpPr txBox="1"/>
          <p:nvPr/>
        </p:nvSpPr>
        <p:spPr>
          <a:xfrm>
            <a:off x="2577306" y="5190391"/>
            <a:ext cx="79794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1 :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full propagation, simulated with FDTD method, behaviour of the electric field for 532 nm light source where the electromagnetic field propagation is shown as a function of the simulation time. Colour represent the electric field intensity form minimum (blue) to maximum (red)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0125355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8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1">
            <a:extLst>
              <a:ext uri="{FF2B5EF4-FFF2-40B4-BE49-F238E27FC236}">
                <a16:creationId xmlns:a16="http://schemas.microsoft.com/office/drawing/2014/main" id="{4BE83654-FF1E-45A8-9334-2FD37A1D4663}"/>
              </a:ext>
            </a:extLst>
          </p:cNvPr>
          <p:cNvSpPr txBox="1"/>
          <p:nvPr/>
        </p:nvSpPr>
        <p:spPr>
          <a:xfrm>
            <a:off x="2106251" y="4146800"/>
            <a:ext cx="79794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1 bis : (a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arting of the propagation of the electri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</a:rPr>
              <a:t>c field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ssociated with the excitation wavelength of 532 nm, in the simulation region, (b) Maximum intensity of the electric field inside the Si-NP. Colour represent the electric field intensity from minimum (blue) to maximum (red).</a:t>
            </a:r>
            <a:endParaRPr lang="it-IT" dirty="0"/>
          </a:p>
        </p:txBody>
      </p: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FA57DD13-55DC-4CBF-BD36-015D4681E9E5}"/>
              </a:ext>
            </a:extLst>
          </p:cNvPr>
          <p:cNvGrpSpPr/>
          <p:nvPr/>
        </p:nvGrpSpPr>
        <p:grpSpPr>
          <a:xfrm>
            <a:off x="466987" y="863313"/>
            <a:ext cx="11562060" cy="2887320"/>
            <a:chOff x="466987" y="863313"/>
            <a:chExt cx="11562060" cy="2887320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CF586F8D-DE53-4B33-80B4-F1FA9BCE54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20499" y="981512"/>
              <a:ext cx="5368955" cy="2684478"/>
            </a:xfrm>
            <a:prstGeom prst="rect">
              <a:avLst/>
            </a:prstGeom>
          </p:spPr>
        </p:pic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38019C04-FD2D-4770-9581-E0CF312EAFE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6987" y="981512"/>
              <a:ext cx="5368956" cy="2684478"/>
            </a:xfrm>
            <a:prstGeom prst="rect">
              <a:avLst/>
            </a:prstGeom>
          </p:spPr>
        </p:pic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35024D33-8978-4A52-B5A6-0A5753CEB97A}"/>
                </a:ext>
              </a:extLst>
            </p:cNvPr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2" t="2534" b="8958"/>
            <a:stretch/>
          </p:blipFill>
          <p:spPr bwMode="auto">
            <a:xfrm>
              <a:off x="11414621" y="863313"/>
              <a:ext cx="614426" cy="288732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8A057899-9D4D-426D-9081-9409D280B643}"/>
                </a:ext>
              </a:extLst>
            </p:cNvPr>
            <p:cNvSpPr txBox="1"/>
            <p:nvPr/>
          </p:nvSpPr>
          <p:spPr>
            <a:xfrm>
              <a:off x="551996" y="981512"/>
              <a:ext cx="67741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>
                  <a:solidFill>
                    <a:schemeClr val="bg1"/>
                  </a:solidFill>
                </a:rPr>
                <a:t>(a)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FA4BC141-D1E3-4D27-AF28-1AF7B6409562}"/>
                </a:ext>
              </a:extLst>
            </p:cNvPr>
            <p:cNvSpPr txBox="1"/>
            <p:nvPr/>
          </p:nvSpPr>
          <p:spPr>
            <a:xfrm>
              <a:off x="6050280" y="981512"/>
              <a:ext cx="67741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>
                  <a:solidFill>
                    <a:schemeClr val="bg1"/>
                  </a:solidFill>
                </a:rPr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610789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633">
            <a:hlinkClick r:id="" action="ppaction://media"/>
            <a:extLst>
              <a:ext uri="{FF2B5EF4-FFF2-40B4-BE49-F238E27FC236}">
                <a16:creationId xmlns:a16="http://schemas.microsoft.com/office/drawing/2014/main" id="{EC84CEC0-8DC7-134F-0AFE-4057543A61A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53467" y="292963"/>
            <a:ext cx="9088274" cy="4544137"/>
          </a:xfrm>
          <a:prstGeom prst="rect">
            <a:avLst/>
          </a:prstGeom>
        </p:spPr>
      </p:pic>
      <p:sp>
        <p:nvSpPr>
          <p:cNvPr id="5" name="CasellaDiTesto 6">
            <a:extLst>
              <a:ext uri="{FF2B5EF4-FFF2-40B4-BE49-F238E27FC236}">
                <a16:creationId xmlns:a16="http://schemas.microsoft.com/office/drawing/2014/main" id="{30F98F7C-5FED-8830-9277-2330BD5D7CBC}"/>
              </a:ext>
            </a:extLst>
          </p:cNvPr>
          <p:cNvSpPr txBox="1"/>
          <p:nvPr/>
        </p:nvSpPr>
        <p:spPr>
          <a:xfrm>
            <a:off x="5659619" y="4163665"/>
            <a:ext cx="942109" cy="3786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633 nm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594EC69-CD55-D454-3EEC-D146C5D4DE1C}"/>
              </a:ext>
            </a:extLst>
          </p:cNvPr>
          <p:cNvSpPr txBox="1"/>
          <p:nvPr/>
        </p:nvSpPr>
        <p:spPr>
          <a:xfrm>
            <a:off x="2435101" y="5295573"/>
            <a:ext cx="79794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2 :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full propagation, simulated with FDTD method, behaviour of the electric field for 633 nm light source where the electromagnetic field propagation is shown as a function of the simulation time. Colour represent the electric field intensity form minimum (blue) to maximum (red)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3269198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8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F65BA940-23AD-4720-AC89-A96AC16C4E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040932"/>
            <a:ext cx="5357769" cy="2678885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4A470B53-3D4E-4C0A-B760-F831E7C21A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026" y="1040932"/>
            <a:ext cx="5357769" cy="2678885"/>
          </a:xfrm>
          <a:prstGeom prst="rect">
            <a:avLst/>
          </a:prstGeom>
        </p:spPr>
      </p:pic>
      <p:sp>
        <p:nvSpPr>
          <p:cNvPr id="8" name="TextBox 1">
            <a:extLst>
              <a:ext uri="{FF2B5EF4-FFF2-40B4-BE49-F238E27FC236}">
                <a16:creationId xmlns:a16="http://schemas.microsoft.com/office/drawing/2014/main" id="{2E829B94-CF78-449B-894D-2CEA6402EF09}"/>
              </a:ext>
            </a:extLst>
          </p:cNvPr>
          <p:cNvSpPr txBox="1"/>
          <p:nvPr/>
        </p:nvSpPr>
        <p:spPr>
          <a:xfrm>
            <a:off x="2106251" y="4146800"/>
            <a:ext cx="79794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2 bis : (a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arting of the propagation of the electri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</a:rPr>
              <a:t>c field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ssociated with the excitation wavelength of 633 nm, in the simulation region, (b) Maximum intensity of the electric field inside the Si-NP. Colour represent the electric field intensity from minimum (blue) to maximum (red).</a:t>
            </a:r>
            <a:endParaRPr lang="it-IT" dirty="0"/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0AEAEF36-EFEF-4CBE-88E8-B6EC3CE7BA35}"/>
              </a:ext>
            </a:extLst>
          </p:cNvPr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2" t="2534" b="8958"/>
          <a:stretch/>
        </p:blipFill>
        <p:spPr bwMode="auto">
          <a:xfrm>
            <a:off x="11495714" y="911547"/>
            <a:ext cx="614426" cy="28873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4E1FBB2-55E4-4441-9465-8B57705F1A42}"/>
              </a:ext>
            </a:extLst>
          </p:cNvPr>
          <p:cNvSpPr txBox="1"/>
          <p:nvPr/>
        </p:nvSpPr>
        <p:spPr>
          <a:xfrm>
            <a:off x="597716" y="1073683"/>
            <a:ext cx="6774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(a)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5FA9997-AC73-4CF5-9907-986EED2DC256}"/>
              </a:ext>
            </a:extLst>
          </p:cNvPr>
          <p:cNvSpPr txBox="1"/>
          <p:nvPr/>
        </p:nvSpPr>
        <p:spPr>
          <a:xfrm>
            <a:off x="6096000" y="1073683"/>
            <a:ext cx="6774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3019509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785">
            <a:hlinkClick r:id="" action="ppaction://media"/>
            <a:extLst>
              <a:ext uri="{FF2B5EF4-FFF2-40B4-BE49-F238E27FC236}">
                <a16:creationId xmlns:a16="http://schemas.microsoft.com/office/drawing/2014/main" id="{6A15F80E-B325-DD28-D67C-CE208DF5F11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17922" y="345546"/>
            <a:ext cx="9556155" cy="4747351"/>
          </a:xfrm>
          <a:prstGeom prst="rect">
            <a:avLst/>
          </a:prstGeom>
        </p:spPr>
      </p:pic>
      <p:sp>
        <p:nvSpPr>
          <p:cNvPr id="5" name="CasellaDiTesto 8">
            <a:extLst>
              <a:ext uri="{FF2B5EF4-FFF2-40B4-BE49-F238E27FC236}">
                <a16:creationId xmlns:a16="http://schemas.microsoft.com/office/drawing/2014/main" id="{45EA6A2F-93D7-7C7C-7A1A-4DB1D543B456}"/>
              </a:ext>
            </a:extLst>
          </p:cNvPr>
          <p:cNvSpPr txBox="1"/>
          <p:nvPr/>
        </p:nvSpPr>
        <p:spPr>
          <a:xfrm>
            <a:off x="5823731" y="4644382"/>
            <a:ext cx="1296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785 nm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D0554D-17C7-7A1D-5ABE-A732A4D4FFA7}"/>
              </a:ext>
            </a:extLst>
          </p:cNvPr>
          <p:cNvSpPr txBox="1"/>
          <p:nvPr/>
        </p:nvSpPr>
        <p:spPr>
          <a:xfrm>
            <a:off x="2497245" y="5304691"/>
            <a:ext cx="79794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3 :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full propagation, simulated with FDTD method, behaviour of the electric field for 785 nm light source where the electromagnetic field propagation is shown as a function of the simulation time. Colour represent the electric field intensity form minimum (blue) to maximum (red)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8665870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8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">
            <a:extLst>
              <a:ext uri="{FF2B5EF4-FFF2-40B4-BE49-F238E27FC236}">
                <a16:creationId xmlns:a16="http://schemas.microsoft.com/office/drawing/2014/main" id="{4289AA0C-026C-44A6-94D0-B8DB734F481C}"/>
              </a:ext>
            </a:extLst>
          </p:cNvPr>
          <p:cNvSpPr txBox="1"/>
          <p:nvPr/>
        </p:nvSpPr>
        <p:spPr>
          <a:xfrm>
            <a:off x="2357711" y="4249670"/>
            <a:ext cx="79794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3 bis : (a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arting of the propagation of the electri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</a:rPr>
              <a:t>c field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ssociated with the excitation wavelength of 785 nm, in the simulation region, (b) Maximum intensity of the electric field inside the Si-NP. Colour represent the electric field intensity from minimum (blue) to maximum (red).</a:t>
            </a:r>
            <a:endParaRPr lang="it-IT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54B8D4B-02D9-E2F5-14CA-577DF0DC8B62}"/>
              </a:ext>
            </a:extLst>
          </p:cNvPr>
          <p:cNvGrpSpPr/>
          <p:nvPr/>
        </p:nvGrpSpPr>
        <p:grpSpPr>
          <a:xfrm>
            <a:off x="525780" y="707068"/>
            <a:ext cx="11752592" cy="2887320"/>
            <a:chOff x="525780" y="707068"/>
            <a:chExt cx="11752592" cy="2887320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F37A5164-F078-4AAC-936F-D5A2D509CA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36120" y="872456"/>
              <a:ext cx="5453961" cy="2556544"/>
            </a:xfrm>
            <a:prstGeom prst="rect">
              <a:avLst/>
            </a:prstGeom>
          </p:spPr>
        </p:pic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D55CD15E-BAAD-4746-A3FA-3F755D9110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780" y="872456"/>
              <a:ext cx="5453961" cy="2556544"/>
            </a:xfrm>
            <a:prstGeom prst="rect">
              <a:avLst/>
            </a:prstGeom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0E2198AB-BCFD-4ED8-BF4C-5BC4B9A99726}"/>
                </a:ext>
              </a:extLst>
            </p:cNvPr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2" t="2534" b="8958"/>
            <a:stretch/>
          </p:blipFill>
          <p:spPr bwMode="auto">
            <a:xfrm>
              <a:off x="11663946" y="707068"/>
              <a:ext cx="614426" cy="288732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A3B6233C-7C2A-40AC-B8B2-2378BB6B5030}"/>
                </a:ext>
              </a:extLst>
            </p:cNvPr>
            <p:cNvSpPr txBox="1"/>
            <p:nvPr/>
          </p:nvSpPr>
          <p:spPr>
            <a:xfrm>
              <a:off x="637836" y="872456"/>
              <a:ext cx="67741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>
                  <a:solidFill>
                    <a:schemeClr val="bg1"/>
                  </a:solidFill>
                </a:rPr>
                <a:t>(a)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410C2C58-481A-4510-8767-FFEA71A66DF0}"/>
                </a:ext>
              </a:extLst>
            </p:cNvPr>
            <p:cNvSpPr txBox="1"/>
            <p:nvPr/>
          </p:nvSpPr>
          <p:spPr>
            <a:xfrm>
              <a:off x="6136120" y="872456"/>
              <a:ext cx="67741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>
                  <a:solidFill>
                    <a:schemeClr val="bg1"/>
                  </a:solidFill>
                </a:rPr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942147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5</TotalTime>
  <Words>437</Words>
  <Application>Microsoft Macintosh PowerPoint</Application>
  <PresentationFormat>Widescreen</PresentationFormat>
  <Paragraphs>21</Paragraphs>
  <Slides>7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ello Condorelli</dc:creator>
  <cp:lastModifiedBy>Giovanni Mannino</cp:lastModifiedBy>
  <cp:revision>20</cp:revision>
  <dcterms:created xsi:type="dcterms:W3CDTF">2022-05-30T09:36:48Z</dcterms:created>
  <dcterms:modified xsi:type="dcterms:W3CDTF">2022-12-20T08:12:37Z</dcterms:modified>
</cp:coreProperties>
</file>